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0"/>
  </p:notesMasterIdLst>
  <p:sldIdLst>
    <p:sldId id="261" r:id="rId5"/>
    <p:sldId id="295" r:id="rId6"/>
    <p:sldId id="285" r:id="rId7"/>
    <p:sldId id="297" r:id="rId8"/>
    <p:sldId id="289" r:id="rId9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64" userDrawn="1">
          <p15:clr>
            <a:srgbClr val="A4A3A4"/>
          </p15:clr>
        </p15:guide>
        <p15:guide id="2" pos="21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207"/>
    <p:restoredTop sz="96327"/>
  </p:normalViewPr>
  <p:slideViewPr>
    <p:cSldViewPr showGuides="1">
      <p:cViewPr varScale="1">
        <p:scale>
          <a:sx n="83" d="100"/>
          <a:sy n="83" d="100"/>
        </p:scale>
        <p:origin x="2802" y="102"/>
      </p:cViewPr>
      <p:guideLst>
        <p:guide orient="horz" pos="2664"/>
        <p:guide pos="21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57150" cy="5715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umpf, Elizabeth S." userId="21f33c29-35ec-4d81-9c31-254061671077" providerId="ADAL" clId="{CF89357B-6D7B-4A04-8537-3FF18D5D708C}"/>
    <pc:docChg chg="delSld">
      <pc:chgData name="Stumpf, Elizabeth S." userId="21f33c29-35ec-4d81-9c31-254061671077" providerId="ADAL" clId="{CF89357B-6D7B-4A04-8537-3FF18D5D708C}" dt="2024-04-18T14:05:09.646" v="7" actId="2696"/>
      <pc:docMkLst>
        <pc:docMk/>
      </pc:docMkLst>
      <pc:sldChg chg="del">
        <pc:chgData name="Stumpf, Elizabeth S." userId="21f33c29-35ec-4d81-9c31-254061671077" providerId="ADAL" clId="{CF89357B-6D7B-4A04-8537-3FF18D5D708C}" dt="2024-04-18T14:05:00.098" v="4" actId="2696"/>
        <pc:sldMkLst>
          <pc:docMk/>
          <pc:sldMk cId="1558442657" sldId="259"/>
        </pc:sldMkLst>
      </pc:sldChg>
      <pc:sldChg chg="del">
        <pc:chgData name="Stumpf, Elizabeth S." userId="21f33c29-35ec-4d81-9c31-254061671077" providerId="ADAL" clId="{CF89357B-6D7B-4A04-8537-3FF18D5D708C}" dt="2024-04-18T14:04:51.165" v="1" actId="2696"/>
        <pc:sldMkLst>
          <pc:docMk/>
          <pc:sldMk cId="2433467902" sldId="262"/>
        </pc:sldMkLst>
      </pc:sldChg>
      <pc:sldChg chg="del">
        <pc:chgData name="Stumpf, Elizabeth S." userId="21f33c29-35ec-4d81-9c31-254061671077" providerId="ADAL" clId="{CF89357B-6D7B-4A04-8537-3FF18D5D708C}" dt="2024-04-18T14:04:48.556" v="0" actId="2696"/>
        <pc:sldMkLst>
          <pc:docMk/>
          <pc:sldMk cId="2935324600" sldId="271"/>
        </pc:sldMkLst>
      </pc:sldChg>
      <pc:sldChg chg="del">
        <pc:chgData name="Stumpf, Elizabeth S." userId="21f33c29-35ec-4d81-9c31-254061671077" providerId="ADAL" clId="{CF89357B-6D7B-4A04-8537-3FF18D5D708C}" dt="2024-04-18T14:05:09.646" v="7" actId="2696"/>
        <pc:sldMkLst>
          <pc:docMk/>
          <pc:sldMk cId="4100446587" sldId="278"/>
        </pc:sldMkLst>
      </pc:sldChg>
      <pc:sldChg chg="del">
        <pc:chgData name="Stumpf, Elizabeth S." userId="21f33c29-35ec-4d81-9c31-254061671077" providerId="ADAL" clId="{CF89357B-6D7B-4A04-8537-3FF18D5D708C}" dt="2024-04-18T14:04:54.099" v="2" actId="2696"/>
        <pc:sldMkLst>
          <pc:docMk/>
          <pc:sldMk cId="3281825795" sldId="284"/>
        </pc:sldMkLst>
      </pc:sldChg>
      <pc:sldChg chg="del">
        <pc:chgData name="Stumpf, Elizabeth S." userId="21f33c29-35ec-4d81-9c31-254061671077" providerId="ADAL" clId="{CF89357B-6D7B-4A04-8537-3FF18D5D708C}" dt="2024-04-18T14:05:06.313" v="6" actId="2696"/>
        <pc:sldMkLst>
          <pc:docMk/>
          <pc:sldMk cId="219898002" sldId="287"/>
        </pc:sldMkLst>
      </pc:sldChg>
      <pc:sldChg chg="del">
        <pc:chgData name="Stumpf, Elizabeth S." userId="21f33c29-35ec-4d81-9c31-254061671077" providerId="ADAL" clId="{CF89357B-6D7B-4A04-8537-3FF18D5D708C}" dt="2024-04-18T14:05:03.542" v="5" actId="2696"/>
        <pc:sldMkLst>
          <pc:docMk/>
          <pc:sldMk cId="2755946309" sldId="290"/>
        </pc:sldMkLst>
      </pc:sldChg>
      <pc:sldChg chg="del">
        <pc:chgData name="Stumpf, Elizabeth S." userId="21f33c29-35ec-4d81-9c31-254061671077" providerId="ADAL" clId="{CF89357B-6D7B-4A04-8537-3FF18D5D708C}" dt="2024-04-18T14:04:56.774" v="3" actId="2696"/>
        <pc:sldMkLst>
          <pc:docMk/>
          <pc:sldMk cId="39953958" sldId="29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25D769-ECAA-574F-8E14-EE3FAFB2070E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8FBAD3-43B9-544F-908E-A498AFD8D7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958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8FBAD3-43B9-544F-908E-A498AFD8D7C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820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498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602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623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59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380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323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174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46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632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14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79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F6619-FF3D-3A45-9DC0-7E4B6B6D0601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10E31-9605-0B45-9E33-28DE917BA3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05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png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13" Type="http://schemas.openxmlformats.org/officeDocument/2006/relationships/image" Target="../media/image26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12" Type="http://schemas.openxmlformats.org/officeDocument/2006/relationships/image" Target="../media/image25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5" Type="http://schemas.openxmlformats.org/officeDocument/2006/relationships/image" Target="../media/image18.emf"/><Relationship Id="rId10" Type="http://schemas.openxmlformats.org/officeDocument/2006/relationships/image" Target="../media/image23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Relationship Id="rId14" Type="http://schemas.openxmlformats.org/officeDocument/2006/relationships/image" Target="../media/image2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11" Type="http://schemas.openxmlformats.org/officeDocument/2006/relationships/image" Target="../media/image37.emf"/><Relationship Id="rId5" Type="http://schemas.openxmlformats.org/officeDocument/2006/relationships/image" Target="../media/image31.emf"/><Relationship Id="rId10" Type="http://schemas.openxmlformats.org/officeDocument/2006/relationships/image" Target="../media/image36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7EAA296-8272-B0ED-592C-5EDA8E1497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966"/>
          <a:stretch/>
        </p:blipFill>
        <p:spPr>
          <a:xfrm>
            <a:off x="2445430" y="590825"/>
            <a:ext cx="2014220" cy="170053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F1A8F85-EDE6-3614-ABE8-8A9F711507A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3084"/>
          <a:stretch/>
        </p:blipFill>
        <p:spPr>
          <a:xfrm>
            <a:off x="161932" y="755925"/>
            <a:ext cx="2583815" cy="15354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78DCB06-C5FF-51D6-929D-AB4B5ED3A1F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1570"/>
          <a:stretch/>
        </p:blipFill>
        <p:spPr>
          <a:xfrm>
            <a:off x="4298950" y="524785"/>
            <a:ext cx="2559050" cy="17665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3992F6E-FD9B-3905-1530-1D63CA536623}"/>
              </a:ext>
            </a:extLst>
          </p:cNvPr>
          <p:cNvSpPr txBox="1"/>
          <p:nvPr/>
        </p:nvSpPr>
        <p:spPr>
          <a:xfrm>
            <a:off x="526371" y="2273909"/>
            <a:ext cx="198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LF vs. L-RF initial day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A9D7A32-96D8-D256-8660-44C6A471F0B3}"/>
              </a:ext>
            </a:extLst>
          </p:cNvPr>
          <p:cNvSpPr txBox="1"/>
          <p:nvPr/>
        </p:nvSpPr>
        <p:spPr>
          <a:xfrm>
            <a:off x="2445430" y="2273909"/>
            <a:ext cx="198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RF initial week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5FDF194-6A2E-1A29-1A68-457ADB8A1706}"/>
              </a:ext>
            </a:extLst>
          </p:cNvPr>
          <p:cNvSpPr txBox="1"/>
          <p:nvPr/>
        </p:nvSpPr>
        <p:spPr>
          <a:xfrm>
            <a:off x="4610277" y="2282632"/>
            <a:ext cx="198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RF initial day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529D92-881D-5845-08FE-CBBDB7630078}"/>
              </a:ext>
            </a:extLst>
          </p:cNvPr>
          <p:cNvSpPr txBox="1"/>
          <p:nvPr/>
        </p:nvSpPr>
        <p:spPr>
          <a:xfrm>
            <a:off x="468742" y="8577350"/>
            <a:ext cx="2583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9D27CB-6CFE-6D07-44B7-4808CCC67815}"/>
              </a:ext>
            </a:extLst>
          </p:cNvPr>
          <p:cNvSpPr txBox="1"/>
          <p:nvPr/>
        </p:nvSpPr>
        <p:spPr>
          <a:xfrm>
            <a:off x="2800350" y="129295"/>
            <a:ext cx="13716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T</a:t>
            </a:r>
            <a:endParaRPr lang="en-US" sz="1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1867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7128268-B062-163A-4B1C-2908FB6856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" b="1128"/>
          <a:stretch/>
        </p:blipFill>
        <p:spPr>
          <a:xfrm>
            <a:off x="4435732" y="3216059"/>
            <a:ext cx="2570099" cy="15689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C9DAF46-1DB2-0612-650A-DA9AEEEE7A9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-2474"/>
          <a:stretch/>
        </p:blipFill>
        <p:spPr>
          <a:xfrm>
            <a:off x="2378332" y="3216059"/>
            <a:ext cx="2570099" cy="162613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AFD10A8-708F-E0F5-C5CE-BA5473AAC13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-2262"/>
          <a:stretch/>
        </p:blipFill>
        <p:spPr>
          <a:xfrm>
            <a:off x="320932" y="3066707"/>
            <a:ext cx="2576322" cy="177548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ED6F6F5-57AB-4941-81F5-88ECC28448D7}"/>
              </a:ext>
            </a:extLst>
          </p:cNvPr>
          <p:cNvSpPr txBox="1"/>
          <p:nvPr/>
        </p:nvSpPr>
        <p:spPr>
          <a:xfrm rot="16200000">
            <a:off x="-836982" y="3742980"/>
            <a:ext cx="2078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LF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ms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95D782-0890-791C-DB9A-180476C2AEF4}"/>
              </a:ext>
            </a:extLst>
          </p:cNvPr>
          <p:cNvSpPr txBox="1"/>
          <p:nvPr/>
        </p:nvSpPr>
        <p:spPr>
          <a:xfrm rot="18014119">
            <a:off x="2640704" y="7297660"/>
            <a:ext cx="551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L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214EDC9-FD1B-6055-2480-8101B9D8217B}"/>
              </a:ext>
            </a:extLst>
          </p:cNvPr>
          <p:cNvSpPr txBox="1"/>
          <p:nvPr/>
        </p:nvSpPr>
        <p:spPr>
          <a:xfrm rot="18014119">
            <a:off x="3084593" y="7454567"/>
            <a:ext cx="914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F</a:t>
            </a:r>
            <a:r>
              <a:rPr lang="en-US" sz="12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930462-9F50-FAF9-B3FA-4D238730924C}"/>
              </a:ext>
            </a:extLst>
          </p:cNvPr>
          <p:cNvSpPr txBox="1"/>
          <p:nvPr/>
        </p:nvSpPr>
        <p:spPr>
          <a:xfrm rot="18014119">
            <a:off x="3655483" y="7503225"/>
            <a:ext cx="1067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RF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wk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87D27E-BBCD-BE47-DD37-8A558D87C75E}"/>
              </a:ext>
            </a:extLst>
          </p:cNvPr>
          <p:cNvSpPr txBox="1"/>
          <p:nvPr/>
        </p:nvSpPr>
        <p:spPr>
          <a:xfrm rot="16200000">
            <a:off x="1211504" y="6391460"/>
            <a:ext cx="2078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LF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ms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C4E587D-697E-097F-C39A-FB1A9AD5226A}"/>
              </a:ext>
            </a:extLst>
          </p:cNvPr>
          <p:cNvSpPr txBox="1"/>
          <p:nvPr/>
        </p:nvSpPr>
        <p:spPr>
          <a:xfrm>
            <a:off x="30332" y="8733089"/>
            <a:ext cx="2583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2.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8423FC2-3CE4-E525-1453-8FE74324BE25}"/>
              </a:ext>
            </a:extLst>
          </p:cNvPr>
          <p:cNvSpPr>
            <a:spLocks/>
          </p:cNvSpPr>
          <p:nvPr/>
        </p:nvSpPr>
        <p:spPr>
          <a:xfrm>
            <a:off x="584178" y="3090811"/>
            <a:ext cx="2029968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6A33F9D-F996-CCC4-E1B9-17245B9C75B9}"/>
              </a:ext>
            </a:extLst>
          </p:cNvPr>
          <p:cNvSpPr/>
          <p:nvPr/>
        </p:nvSpPr>
        <p:spPr>
          <a:xfrm>
            <a:off x="2899940" y="3090811"/>
            <a:ext cx="228600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128D20D-5FB6-C35C-B562-12E21FD42678}"/>
              </a:ext>
            </a:extLst>
          </p:cNvPr>
          <p:cNvSpPr/>
          <p:nvPr/>
        </p:nvSpPr>
        <p:spPr>
          <a:xfrm>
            <a:off x="3528590" y="3090811"/>
            <a:ext cx="228600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6E37905-F632-3FC6-C1F3-B7FB54A63A38}"/>
              </a:ext>
            </a:extLst>
          </p:cNvPr>
          <p:cNvSpPr/>
          <p:nvPr/>
        </p:nvSpPr>
        <p:spPr>
          <a:xfrm>
            <a:off x="4157240" y="3090811"/>
            <a:ext cx="228600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1202365-1403-64A3-2BB4-ED0F4BE03681}"/>
              </a:ext>
            </a:extLst>
          </p:cNvPr>
          <p:cNvSpPr/>
          <p:nvPr/>
        </p:nvSpPr>
        <p:spPr>
          <a:xfrm>
            <a:off x="4944390" y="3090811"/>
            <a:ext cx="228600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89CEE80-BFB9-C474-AA2D-527496E31AF7}"/>
              </a:ext>
            </a:extLst>
          </p:cNvPr>
          <p:cNvSpPr/>
          <p:nvPr/>
        </p:nvSpPr>
        <p:spPr>
          <a:xfrm>
            <a:off x="5585946" y="3090811"/>
            <a:ext cx="228600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A66BAE0-C57E-083F-F19A-2016CFAC6104}"/>
              </a:ext>
            </a:extLst>
          </p:cNvPr>
          <p:cNvSpPr/>
          <p:nvPr/>
        </p:nvSpPr>
        <p:spPr>
          <a:xfrm>
            <a:off x="6214652" y="3090811"/>
            <a:ext cx="228600" cy="5486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99853D-36C2-02C7-04F2-DFCB17C763C3}"/>
              </a:ext>
            </a:extLst>
          </p:cNvPr>
          <p:cNvSpPr txBox="1"/>
          <p:nvPr/>
        </p:nvSpPr>
        <p:spPr>
          <a:xfrm>
            <a:off x="480081" y="2813812"/>
            <a:ext cx="138968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ood availability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518D0CD-1A24-09A0-BAAE-E9555EA2D9EC}"/>
              </a:ext>
            </a:extLst>
          </p:cNvPr>
          <p:cNvSpPr txBox="1"/>
          <p:nvPr/>
        </p:nvSpPr>
        <p:spPr>
          <a:xfrm>
            <a:off x="1090148" y="2575640"/>
            <a:ext cx="9164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LF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48D5794-DD2C-6104-4272-022A2C9BBB5D}"/>
              </a:ext>
            </a:extLst>
          </p:cNvPr>
          <p:cNvSpPr txBox="1"/>
          <p:nvPr/>
        </p:nvSpPr>
        <p:spPr>
          <a:xfrm>
            <a:off x="2881872" y="2576904"/>
            <a:ext cx="16253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F</a:t>
            </a:r>
            <a:r>
              <a:rPr lang="en-US" sz="16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2DAA31-7D32-F3F9-45D1-526307A94F33}"/>
              </a:ext>
            </a:extLst>
          </p:cNvPr>
          <p:cNvSpPr txBox="1"/>
          <p:nvPr/>
        </p:nvSpPr>
        <p:spPr>
          <a:xfrm>
            <a:off x="4646160" y="2575640"/>
            <a:ext cx="1876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-RF</a:t>
            </a:r>
            <a:r>
              <a: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wk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398E3A9-A355-550E-EA78-FCF6EB935E7A}"/>
              </a:ext>
            </a:extLst>
          </p:cNvPr>
          <p:cNvCxnSpPr>
            <a:cxnSpLocks/>
          </p:cNvCxnSpPr>
          <p:nvPr/>
        </p:nvCxnSpPr>
        <p:spPr>
          <a:xfrm>
            <a:off x="3063608" y="3721553"/>
            <a:ext cx="0" cy="226503"/>
          </a:xfrm>
          <a:prstGeom prst="line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D9FFFC1D-CE9C-381E-2D9B-A4351D796518}"/>
              </a:ext>
            </a:extLst>
          </p:cNvPr>
          <p:cNvSpPr txBox="1"/>
          <p:nvPr/>
        </p:nvSpPr>
        <p:spPr>
          <a:xfrm>
            <a:off x="2492220" y="3420061"/>
            <a:ext cx="63336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6523E9E-293B-9F59-AF82-20B4ED25D4AA}"/>
              </a:ext>
            </a:extLst>
          </p:cNvPr>
          <p:cNvSpPr txBox="1"/>
          <p:nvPr/>
        </p:nvSpPr>
        <p:spPr>
          <a:xfrm>
            <a:off x="2914650" y="4857750"/>
            <a:ext cx="1178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ZT (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4598CF3D-375B-B9BE-B2C3-708CEA29C71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43150" y="5661998"/>
            <a:ext cx="2388870" cy="160655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E132B3D-E308-12BC-333D-667E6A99EDBA}"/>
              </a:ext>
            </a:extLst>
          </p:cNvPr>
          <p:cNvSpPr txBox="1"/>
          <p:nvPr/>
        </p:nvSpPr>
        <p:spPr>
          <a:xfrm>
            <a:off x="4136123" y="5342616"/>
            <a:ext cx="140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ight cycle</a:t>
            </a:r>
            <a:endParaRPr lang="en-US" sz="12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CE02AF-E55B-A408-242A-885D608373D7}"/>
              </a:ext>
            </a:extLst>
          </p:cNvPr>
          <p:cNvSpPr txBox="1"/>
          <p:nvPr/>
        </p:nvSpPr>
        <p:spPr>
          <a:xfrm>
            <a:off x="4136123" y="5548364"/>
            <a:ext cx="15533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rk cycle</a:t>
            </a: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517B60BD-2EDE-F797-08FC-2C65018E0B12}"/>
              </a:ext>
            </a:extLst>
          </p:cNvPr>
          <p:cNvSpPr/>
          <p:nvPr/>
        </p:nvSpPr>
        <p:spPr>
          <a:xfrm>
            <a:off x="4106278" y="5619615"/>
            <a:ext cx="91440" cy="91440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8B209DCE-CA45-857A-5CF8-BA3846706BAB}"/>
              </a:ext>
            </a:extLst>
          </p:cNvPr>
          <p:cNvSpPr/>
          <p:nvPr/>
        </p:nvSpPr>
        <p:spPr>
          <a:xfrm>
            <a:off x="4106278" y="5452110"/>
            <a:ext cx="91440" cy="9144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2192222-15CF-73E3-DD10-D7FCE43ED2B3}"/>
              </a:ext>
            </a:extLst>
          </p:cNvPr>
          <p:cNvSpPr txBox="1"/>
          <p:nvPr/>
        </p:nvSpPr>
        <p:spPr>
          <a:xfrm>
            <a:off x="2851785" y="2199032"/>
            <a:ext cx="13716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T</a:t>
            </a:r>
            <a:endParaRPr lang="en-US" sz="1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06039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0B44DCAC-0CB8-6F78-A463-74B95C6E25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184"/>
          <a:stretch/>
        </p:blipFill>
        <p:spPr>
          <a:xfrm>
            <a:off x="407743" y="2920379"/>
            <a:ext cx="2468880" cy="265400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360E5175-2756-177A-CEA4-7696B491FA3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512"/>
          <a:stretch/>
        </p:blipFill>
        <p:spPr>
          <a:xfrm>
            <a:off x="2396563" y="3063254"/>
            <a:ext cx="2468880" cy="2511134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E7B4F01-8BB1-F1E5-4D97-32A6DC48ED1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6512"/>
          <a:stretch/>
        </p:blipFill>
        <p:spPr>
          <a:xfrm>
            <a:off x="4339663" y="3063254"/>
            <a:ext cx="2468880" cy="2511134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D48B6459-51F8-E779-8820-F7E1E7D098B6}"/>
              </a:ext>
            </a:extLst>
          </p:cNvPr>
          <p:cNvSpPr/>
          <p:nvPr/>
        </p:nvSpPr>
        <p:spPr>
          <a:xfrm>
            <a:off x="750643" y="2986837"/>
            <a:ext cx="181145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29C361D-531C-1A7B-1CE3-816C22D44956}"/>
              </a:ext>
            </a:extLst>
          </p:cNvPr>
          <p:cNvSpPr/>
          <p:nvPr/>
        </p:nvSpPr>
        <p:spPr>
          <a:xfrm>
            <a:off x="2926585" y="2986837"/>
            <a:ext cx="18613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99F903B-FAE9-DB5B-E65B-9289CADC469D}"/>
              </a:ext>
            </a:extLst>
          </p:cNvPr>
          <p:cNvSpPr/>
          <p:nvPr/>
        </p:nvSpPr>
        <p:spPr>
          <a:xfrm>
            <a:off x="3536884" y="2986837"/>
            <a:ext cx="18613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9695329-E587-D061-DF64-EC5090F61101}"/>
              </a:ext>
            </a:extLst>
          </p:cNvPr>
          <p:cNvSpPr/>
          <p:nvPr/>
        </p:nvSpPr>
        <p:spPr>
          <a:xfrm>
            <a:off x="4147184" y="2986837"/>
            <a:ext cx="18613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9F70F31-81BD-1D9B-7292-D1944F23800B}"/>
              </a:ext>
            </a:extLst>
          </p:cNvPr>
          <p:cNvSpPr/>
          <p:nvPr/>
        </p:nvSpPr>
        <p:spPr>
          <a:xfrm>
            <a:off x="4869685" y="2986837"/>
            <a:ext cx="18613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3F8195A-3598-8E76-8590-5E5134E1FA75}"/>
              </a:ext>
            </a:extLst>
          </p:cNvPr>
          <p:cNvSpPr/>
          <p:nvPr/>
        </p:nvSpPr>
        <p:spPr>
          <a:xfrm>
            <a:off x="5476321" y="2986837"/>
            <a:ext cx="18613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A4E65EA-1045-9413-5DAD-547E4F11CF0C}"/>
              </a:ext>
            </a:extLst>
          </p:cNvPr>
          <p:cNvSpPr/>
          <p:nvPr/>
        </p:nvSpPr>
        <p:spPr>
          <a:xfrm>
            <a:off x="6086621" y="2986837"/>
            <a:ext cx="186137" cy="7006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7AFA844-F044-FD6E-2F2B-C03F0E7BB677}"/>
              </a:ext>
            </a:extLst>
          </p:cNvPr>
          <p:cNvSpPr txBox="1"/>
          <p:nvPr/>
        </p:nvSpPr>
        <p:spPr>
          <a:xfrm>
            <a:off x="2561783" y="3269762"/>
            <a:ext cx="63336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E5F1B62-D4B0-E20B-3339-6391FCC57A87}"/>
              </a:ext>
            </a:extLst>
          </p:cNvPr>
          <p:cNvSpPr txBox="1"/>
          <p:nvPr/>
        </p:nvSpPr>
        <p:spPr>
          <a:xfrm>
            <a:off x="257589" y="2714004"/>
            <a:ext cx="138968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ood availability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298F1DC-1753-243F-C42C-A1FC0A91D0DA}"/>
              </a:ext>
            </a:extLst>
          </p:cNvPr>
          <p:cNvSpPr txBox="1"/>
          <p:nvPr/>
        </p:nvSpPr>
        <p:spPr>
          <a:xfrm rot="16200000">
            <a:off x="-751446" y="3933346"/>
            <a:ext cx="20787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nterval (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AB99AA09-8797-BED3-A7B5-D16086671D52}"/>
              </a:ext>
            </a:extLst>
          </p:cNvPr>
          <p:cNvCxnSpPr>
            <a:cxnSpLocks/>
          </p:cNvCxnSpPr>
          <p:nvPr/>
        </p:nvCxnSpPr>
        <p:spPr>
          <a:xfrm>
            <a:off x="3131894" y="3579701"/>
            <a:ext cx="0" cy="226503"/>
          </a:xfrm>
          <a:prstGeom prst="line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3" name="Picture 92" descr="Text&#10;&#10;Description automatically generated">
            <a:extLst>
              <a:ext uri="{FF2B5EF4-FFF2-40B4-BE49-F238E27FC236}">
                <a16:creationId xmlns:a16="http://schemas.microsoft.com/office/drawing/2014/main" id="{3D459DB9-0EC3-BE17-1425-7A99D8BC534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026" t="12496" r="26724"/>
          <a:stretch/>
        </p:blipFill>
        <p:spPr>
          <a:xfrm>
            <a:off x="2105844" y="593527"/>
            <a:ext cx="2796772" cy="1899334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AAE9DFDE-D182-D7AD-0ED7-79D1BFEFFA95}"/>
              </a:ext>
            </a:extLst>
          </p:cNvPr>
          <p:cNvSpPr txBox="1"/>
          <p:nvPr/>
        </p:nvSpPr>
        <p:spPr>
          <a:xfrm>
            <a:off x="3081138" y="57150"/>
            <a:ext cx="129301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cn5a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/</a:t>
            </a:r>
            <a:r>
              <a:rPr lang="el-GR" sz="14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Δ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PQ</a:t>
            </a:r>
            <a:endParaRPr lang="en-US" sz="14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5B95466-7F62-AD1E-1325-93818E7B1FFF}"/>
              </a:ext>
            </a:extLst>
          </p:cNvPr>
          <p:cNvSpPr txBox="1"/>
          <p:nvPr/>
        </p:nvSpPr>
        <p:spPr>
          <a:xfrm>
            <a:off x="2057400" y="338682"/>
            <a:ext cx="9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LF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8D2EC66-AD4A-5822-ECFC-AE8340450E3F}"/>
              </a:ext>
            </a:extLst>
          </p:cNvPr>
          <p:cNvSpPr txBox="1"/>
          <p:nvPr/>
        </p:nvSpPr>
        <p:spPr>
          <a:xfrm>
            <a:off x="2718288" y="338682"/>
            <a:ext cx="1625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F</a:t>
            </a:r>
            <a:r>
              <a:rPr lang="en-US" sz="12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560659A-F2F4-2225-FF8B-CE8315C30BFF}"/>
              </a:ext>
            </a:extLst>
          </p:cNvPr>
          <p:cNvSpPr txBox="1"/>
          <p:nvPr/>
        </p:nvSpPr>
        <p:spPr>
          <a:xfrm>
            <a:off x="3644356" y="338682"/>
            <a:ext cx="187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RF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wk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8E0E96C-C3E0-61AC-F165-2502CA076340}"/>
              </a:ext>
            </a:extLst>
          </p:cNvPr>
          <p:cNvSpPr txBox="1"/>
          <p:nvPr/>
        </p:nvSpPr>
        <p:spPr>
          <a:xfrm>
            <a:off x="1210388" y="2491370"/>
            <a:ext cx="9164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LF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7978A37-A265-2E53-2C8F-0BA6B1AA4F1B}"/>
              </a:ext>
            </a:extLst>
          </p:cNvPr>
          <p:cNvSpPr txBox="1"/>
          <p:nvPr/>
        </p:nvSpPr>
        <p:spPr>
          <a:xfrm>
            <a:off x="2866747" y="2492634"/>
            <a:ext cx="16253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F</a:t>
            </a:r>
            <a:r>
              <a:rPr lang="en-US" sz="16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ED8F38B-3084-FCE5-AF1A-36C7027C4C14}"/>
              </a:ext>
            </a:extLst>
          </p:cNvPr>
          <p:cNvSpPr txBox="1"/>
          <p:nvPr/>
        </p:nvSpPr>
        <p:spPr>
          <a:xfrm>
            <a:off x="4631035" y="2491370"/>
            <a:ext cx="1876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-RF</a:t>
            </a:r>
            <a:r>
              <a: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w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F8B0C2-2C8A-D63A-498F-F8AD5418085F}"/>
              </a:ext>
            </a:extLst>
          </p:cNvPr>
          <p:cNvSpPr txBox="1"/>
          <p:nvPr/>
        </p:nvSpPr>
        <p:spPr>
          <a:xfrm rot="16200000">
            <a:off x="-736057" y="5912458"/>
            <a:ext cx="2078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b (</a:t>
            </a:r>
            <a:r>
              <a:rPr lang="en-US" sz="14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34A02C6-0A30-5C12-4EC6-7082B491B737}"/>
              </a:ext>
            </a:extLst>
          </p:cNvPr>
          <p:cNvSpPr txBox="1"/>
          <p:nvPr/>
        </p:nvSpPr>
        <p:spPr>
          <a:xfrm>
            <a:off x="2857500" y="7143750"/>
            <a:ext cx="1178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ZT (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C3C866-6413-0A8F-5862-4F7FA342F699}"/>
              </a:ext>
            </a:extLst>
          </p:cNvPr>
          <p:cNvSpPr txBox="1"/>
          <p:nvPr/>
        </p:nvSpPr>
        <p:spPr>
          <a:xfrm>
            <a:off x="136319" y="-4405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D4CB253-5972-E64E-5549-DDB9DA6CA8CE}"/>
              </a:ext>
            </a:extLst>
          </p:cNvPr>
          <p:cNvSpPr txBox="1"/>
          <p:nvPr/>
        </p:nvSpPr>
        <p:spPr>
          <a:xfrm>
            <a:off x="127990" y="2431018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20F9A2D-2DB4-D6B2-EA25-30F5DE34E14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456" y="5543550"/>
            <a:ext cx="2091690" cy="14287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2777EAB-E5CE-CA13-9F74-0AB9646FA7D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66151" y="5680710"/>
            <a:ext cx="1943100" cy="12915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96620FA-0F32-D6C2-EC61-5D54E910F7F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12322" y="5680710"/>
            <a:ext cx="1943100" cy="129159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41CD0F-2BFD-4A2F-6DF5-97F0B07A59DD}"/>
              </a:ext>
            </a:extLst>
          </p:cNvPr>
          <p:cNvSpPr txBox="1"/>
          <p:nvPr/>
        </p:nvSpPr>
        <p:spPr>
          <a:xfrm>
            <a:off x="750643" y="3380664"/>
            <a:ext cx="57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737D7D-28B9-278D-ECC6-2F5B85ABB44C}"/>
              </a:ext>
            </a:extLst>
          </p:cNvPr>
          <p:cNvSpPr txBox="1"/>
          <p:nvPr/>
        </p:nvSpPr>
        <p:spPr>
          <a:xfrm>
            <a:off x="750643" y="4341195"/>
            <a:ext cx="57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Q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90EBEF-6B21-1C19-E4E7-C8F47B7AB0C3}"/>
              </a:ext>
            </a:extLst>
          </p:cNvPr>
          <p:cNvSpPr txBox="1"/>
          <p:nvPr/>
        </p:nvSpPr>
        <p:spPr>
          <a:xfrm>
            <a:off x="750643" y="5257800"/>
            <a:ext cx="57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778630-9C21-0FE2-D182-FBCD08542442}"/>
              </a:ext>
            </a:extLst>
          </p:cNvPr>
          <p:cNvSpPr txBox="1"/>
          <p:nvPr/>
        </p:nvSpPr>
        <p:spPr>
          <a:xfrm>
            <a:off x="719131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FF0185-0BEE-380E-FC99-CC7840783A96}"/>
              </a:ext>
            </a:extLst>
          </p:cNvPr>
          <p:cNvSpPr txBox="1"/>
          <p:nvPr/>
        </p:nvSpPr>
        <p:spPr>
          <a:xfrm>
            <a:off x="973168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04D763-B7EE-9651-4046-50CF3E94DB02}"/>
              </a:ext>
            </a:extLst>
          </p:cNvPr>
          <p:cNvSpPr txBox="1"/>
          <p:nvPr/>
        </p:nvSpPr>
        <p:spPr>
          <a:xfrm>
            <a:off x="1358023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5C0861E-16B7-0C48-3E14-99E8A9D77A5F}"/>
              </a:ext>
            </a:extLst>
          </p:cNvPr>
          <p:cNvSpPr txBox="1"/>
          <p:nvPr/>
        </p:nvSpPr>
        <p:spPr>
          <a:xfrm>
            <a:off x="1612060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535608D-8A54-A976-6DE4-A697BBD5645E}"/>
              </a:ext>
            </a:extLst>
          </p:cNvPr>
          <p:cNvSpPr txBox="1"/>
          <p:nvPr/>
        </p:nvSpPr>
        <p:spPr>
          <a:xfrm>
            <a:off x="1996915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FA2786F-496A-6CA8-D85F-2A96D462D35D}"/>
              </a:ext>
            </a:extLst>
          </p:cNvPr>
          <p:cNvSpPr txBox="1"/>
          <p:nvPr/>
        </p:nvSpPr>
        <p:spPr>
          <a:xfrm>
            <a:off x="2250953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CCEC6B3-8969-9B18-2E24-A2D95C14DB24}"/>
              </a:ext>
            </a:extLst>
          </p:cNvPr>
          <p:cNvSpPr txBox="1"/>
          <p:nvPr/>
        </p:nvSpPr>
        <p:spPr>
          <a:xfrm>
            <a:off x="2805846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D1660C7-282E-9815-F52D-2D0DB93D8971}"/>
              </a:ext>
            </a:extLst>
          </p:cNvPr>
          <p:cNvSpPr txBox="1"/>
          <p:nvPr/>
        </p:nvSpPr>
        <p:spPr>
          <a:xfrm>
            <a:off x="3059883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C3B22E1-1BFF-638A-6E10-8FD805FA087E}"/>
              </a:ext>
            </a:extLst>
          </p:cNvPr>
          <p:cNvSpPr txBox="1"/>
          <p:nvPr/>
        </p:nvSpPr>
        <p:spPr>
          <a:xfrm>
            <a:off x="3444738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A223C9A-6375-B0ED-5339-C971E1C8B3C0}"/>
              </a:ext>
            </a:extLst>
          </p:cNvPr>
          <p:cNvSpPr txBox="1"/>
          <p:nvPr/>
        </p:nvSpPr>
        <p:spPr>
          <a:xfrm>
            <a:off x="3698775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79C12A3-5BC9-E336-59F4-AE2AC363C7E8}"/>
              </a:ext>
            </a:extLst>
          </p:cNvPr>
          <p:cNvSpPr txBox="1"/>
          <p:nvPr/>
        </p:nvSpPr>
        <p:spPr>
          <a:xfrm>
            <a:off x="4083630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70AC1FD-4EFC-C53B-9C14-54DD82A36D92}"/>
              </a:ext>
            </a:extLst>
          </p:cNvPr>
          <p:cNvSpPr txBox="1"/>
          <p:nvPr/>
        </p:nvSpPr>
        <p:spPr>
          <a:xfrm>
            <a:off x="4337668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6E2B82C-EAF9-4A0A-733F-9020FFE1CF3D}"/>
              </a:ext>
            </a:extLst>
          </p:cNvPr>
          <p:cNvSpPr txBox="1"/>
          <p:nvPr/>
        </p:nvSpPr>
        <p:spPr>
          <a:xfrm>
            <a:off x="4847806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FDAE665-148B-B368-BE03-FED23112DDC6}"/>
              </a:ext>
            </a:extLst>
          </p:cNvPr>
          <p:cNvSpPr txBox="1"/>
          <p:nvPr/>
        </p:nvSpPr>
        <p:spPr>
          <a:xfrm>
            <a:off x="5101843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37F35B3-DD07-57D9-9CDE-D2EC3F56535A}"/>
              </a:ext>
            </a:extLst>
          </p:cNvPr>
          <p:cNvSpPr txBox="1"/>
          <p:nvPr/>
        </p:nvSpPr>
        <p:spPr>
          <a:xfrm>
            <a:off x="5486698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F83AA55-5F28-DDB2-64FB-A9BF9B71BAEB}"/>
              </a:ext>
            </a:extLst>
          </p:cNvPr>
          <p:cNvSpPr txBox="1"/>
          <p:nvPr/>
        </p:nvSpPr>
        <p:spPr>
          <a:xfrm>
            <a:off x="5740735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851C321-DBE1-1DE5-2A80-EED39E6CCB50}"/>
              </a:ext>
            </a:extLst>
          </p:cNvPr>
          <p:cNvSpPr txBox="1"/>
          <p:nvPr/>
        </p:nvSpPr>
        <p:spPr>
          <a:xfrm>
            <a:off x="6125590" y="6918924"/>
            <a:ext cx="232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7ECDBA2-4CBA-D794-1811-A4B9C6109259}"/>
              </a:ext>
            </a:extLst>
          </p:cNvPr>
          <p:cNvSpPr txBox="1"/>
          <p:nvPr/>
        </p:nvSpPr>
        <p:spPr>
          <a:xfrm>
            <a:off x="6379628" y="6918924"/>
            <a:ext cx="363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41754D3-D9B3-6C58-7A96-07FEFED81CB9}"/>
              </a:ext>
            </a:extLst>
          </p:cNvPr>
          <p:cNvSpPr txBox="1"/>
          <p:nvPr/>
        </p:nvSpPr>
        <p:spPr>
          <a:xfrm>
            <a:off x="30332" y="8733089"/>
            <a:ext cx="2583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3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BA3DFD-64A2-2BE7-E862-489D435A0364}"/>
              </a:ext>
            </a:extLst>
          </p:cNvPr>
          <p:cNvSpPr txBox="1"/>
          <p:nvPr/>
        </p:nvSpPr>
        <p:spPr>
          <a:xfrm>
            <a:off x="2161007" y="836791"/>
            <a:ext cx="2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2D3EC5-8142-F8B8-D6D9-9773EAA18DC7}"/>
              </a:ext>
            </a:extLst>
          </p:cNvPr>
          <p:cNvSpPr txBox="1"/>
          <p:nvPr/>
        </p:nvSpPr>
        <p:spPr>
          <a:xfrm>
            <a:off x="2324217" y="1024635"/>
            <a:ext cx="2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Q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D016B69-7CF1-E32B-15D9-602D12FFDD44}"/>
              </a:ext>
            </a:extLst>
          </p:cNvPr>
          <p:cNvSpPr txBox="1"/>
          <p:nvPr/>
        </p:nvSpPr>
        <p:spPr>
          <a:xfrm>
            <a:off x="2467305" y="480357"/>
            <a:ext cx="2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3E7D3D1-4ABB-E479-0F0A-517FB517AC8F}"/>
              </a:ext>
            </a:extLst>
          </p:cNvPr>
          <p:cNvSpPr txBox="1"/>
          <p:nvPr/>
        </p:nvSpPr>
        <p:spPr>
          <a:xfrm>
            <a:off x="2487427" y="1216296"/>
            <a:ext cx="2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99C9B0-9B3E-E914-6687-9DAD44D2043F}"/>
              </a:ext>
            </a:extLst>
          </p:cNvPr>
          <p:cNvSpPr txBox="1"/>
          <p:nvPr/>
        </p:nvSpPr>
        <p:spPr>
          <a:xfrm>
            <a:off x="2515659" y="737562"/>
            <a:ext cx="2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J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63C81C3-F360-8C3A-9B39-A028DB94A71C}"/>
              </a:ext>
            </a:extLst>
          </p:cNvPr>
          <p:cNvSpPr txBox="1"/>
          <p:nvPr/>
        </p:nvSpPr>
        <p:spPr>
          <a:xfrm>
            <a:off x="2620417" y="1071450"/>
            <a:ext cx="2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</a:t>
            </a:r>
          </a:p>
        </p:txBody>
      </p:sp>
    </p:spTree>
    <p:extLst>
      <p:ext uri="{BB962C8B-B14F-4D97-AF65-F5344CB8AC3E}">
        <p14:creationId xmlns:p14="http://schemas.microsoft.com/office/powerpoint/2010/main" val="89804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TextBox 129">
            <a:extLst>
              <a:ext uri="{FF2B5EF4-FFF2-40B4-BE49-F238E27FC236}">
                <a16:creationId xmlns:a16="http://schemas.microsoft.com/office/drawing/2014/main" id="{D07DE64B-1D38-CF40-BF7C-1DF1900A2B0A}"/>
              </a:ext>
            </a:extLst>
          </p:cNvPr>
          <p:cNvSpPr txBox="1"/>
          <p:nvPr/>
        </p:nvSpPr>
        <p:spPr>
          <a:xfrm>
            <a:off x="468742" y="8577350"/>
            <a:ext cx="2788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2D9E8F7-4761-B349-9673-0E7D08AFF02E}"/>
              </a:ext>
            </a:extLst>
          </p:cNvPr>
          <p:cNvGrpSpPr/>
          <p:nvPr/>
        </p:nvGrpSpPr>
        <p:grpSpPr>
          <a:xfrm>
            <a:off x="514350" y="1022351"/>
            <a:ext cx="5943600" cy="6413498"/>
            <a:chOff x="342900" y="618794"/>
            <a:chExt cx="5943600" cy="6413498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43EEBA0-5115-B466-D906-A707F51B4AF2}"/>
                </a:ext>
              </a:extLst>
            </p:cNvPr>
            <p:cNvSpPr txBox="1"/>
            <p:nvPr/>
          </p:nvSpPr>
          <p:spPr>
            <a:xfrm rot="16200000">
              <a:off x="69733" y="1752352"/>
              <a:ext cx="14808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phase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ZT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DDEFD20-E117-3D8E-A287-702D653CBF00}"/>
                </a:ext>
              </a:extLst>
            </p:cNvPr>
            <p:cNvSpPr txBox="1"/>
            <p:nvPr/>
          </p:nvSpPr>
          <p:spPr>
            <a:xfrm rot="18014119">
              <a:off x="980576" y="2532052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2AC922D-D230-91A7-116E-A9E3DADFD0CF}"/>
                </a:ext>
              </a:extLst>
            </p:cNvPr>
            <p:cNvSpPr txBox="1"/>
            <p:nvPr/>
          </p:nvSpPr>
          <p:spPr>
            <a:xfrm rot="18014119">
              <a:off x="989523" y="2688959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135C065-C040-3B8C-1279-428EBD5054D6}"/>
                </a:ext>
              </a:extLst>
            </p:cNvPr>
            <p:cNvSpPr txBox="1"/>
            <p:nvPr/>
          </p:nvSpPr>
          <p:spPr>
            <a:xfrm rot="18014119">
              <a:off x="1182676" y="2754988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64B8B13-13EF-F9BA-7EE8-1954046D9CF4}"/>
                </a:ext>
              </a:extLst>
            </p:cNvPr>
            <p:cNvSpPr txBox="1"/>
            <p:nvPr/>
          </p:nvSpPr>
          <p:spPr>
            <a:xfrm rot="18014119">
              <a:off x="2301300" y="2532052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D45D7BF-B35F-7F22-A6B3-A96C3E1FEF4C}"/>
                </a:ext>
              </a:extLst>
            </p:cNvPr>
            <p:cNvSpPr txBox="1"/>
            <p:nvPr/>
          </p:nvSpPr>
          <p:spPr>
            <a:xfrm rot="18014119">
              <a:off x="2310247" y="2688959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AD625E6-8867-D4A2-35FA-E2C35A15F211}"/>
                </a:ext>
              </a:extLst>
            </p:cNvPr>
            <p:cNvSpPr txBox="1"/>
            <p:nvPr/>
          </p:nvSpPr>
          <p:spPr>
            <a:xfrm rot="18014119">
              <a:off x="2503400" y="2754988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BDE3ADC-83E5-FD40-C295-84A784B376BB}"/>
                </a:ext>
              </a:extLst>
            </p:cNvPr>
            <p:cNvSpPr txBox="1"/>
            <p:nvPr/>
          </p:nvSpPr>
          <p:spPr>
            <a:xfrm rot="18014119">
              <a:off x="3597692" y="2532052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03CDBFD-0816-4338-AC10-0F2FC6B869A8}"/>
                </a:ext>
              </a:extLst>
            </p:cNvPr>
            <p:cNvSpPr txBox="1"/>
            <p:nvPr/>
          </p:nvSpPr>
          <p:spPr>
            <a:xfrm rot="18014119">
              <a:off x="3606639" y="2688959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8FDB9E7-7330-29C5-7919-EEC1BF685127}"/>
                </a:ext>
              </a:extLst>
            </p:cNvPr>
            <p:cNvSpPr txBox="1"/>
            <p:nvPr/>
          </p:nvSpPr>
          <p:spPr>
            <a:xfrm rot="18014119">
              <a:off x="3799792" y="2754988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2C98478-1EB8-34C4-5AEB-93D3C4950F38}"/>
                </a:ext>
              </a:extLst>
            </p:cNvPr>
            <p:cNvSpPr txBox="1"/>
            <p:nvPr/>
          </p:nvSpPr>
          <p:spPr>
            <a:xfrm rot="18014119">
              <a:off x="4911774" y="2532052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90F1DB8-6A92-CB9C-D75A-40C477170643}"/>
                </a:ext>
              </a:extLst>
            </p:cNvPr>
            <p:cNvSpPr txBox="1"/>
            <p:nvPr/>
          </p:nvSpPr>
          <p:spPr>
            <a:xfrm rot="18014119">
              <a:off x="4920721" y="2688959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310E407-53A3-F6F6-0882-F4AC054564D4}"/>
                </a:ext>
              </a:extLst>
            </p:cNvPr>
            <p:cNvSpPr txBox="1"/>
            <p:nvPr/>
          </p:nvSpPr>
          <p:spPr>
            <a:xfrm rot="18014119">
              <a:off x="5113874" y="2754988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B3711FE8-794E-11CA-C395-10407A616FC2}"/>
                </a:ext>
              </a:extLst>
            </p:cNvPr>
            <p:cNvGrpSpPr/>
            <p:nvPr/>
          </p:nvGrpSpPr>
          <p:grpSpPr>
            <a:xfrm>
              <a:off x="1626939" y="618794"/>
              <a:ext cx="3740141" cy="327227"/>
              <a:chOff x="1931617" y="2637753"/>
              <a:chExt cx="3740141" cy="327227"/>
            </a:xfrm>
          </p:grpSpPr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5183F4A0-D46F-D051-9179-6E6EF86F63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9135" t="69" r="12070" b="92180"/>
              <a:stretch/>
            </p:blipFill>
            <p:spPr>
              <a:xfrm>
                <a:off x="1931617" y="2669653"/>
                <a:ext cx="3337564" cy="295327"/>
              </a:xfrm>
              <a:prstGeom prst="rect">
                <a:avLst/>
              </a:prstGeom>
            </p:spPr>
          </p:pic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25DCE26F-BA7C-BC65-8257-D11A1B5DF4F3}"/>
                  </a:ext>
                </a:extLst>
              </p:cNvPr>
              <p:cNvSpPr txBox="1"/>
              <p:nvPr/>
            </p:nvSpPr>
            <p:spPr>
              <a:xfrm>
                <a:off x="2088758" y="2637753"/>
                <a:ext cx="6997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R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9F7EF7FC-D142-BE5E-EF1A-38F0B8C65BDD}"/>
                  </a:ext>
                </a:extLst>
              </p:cNvPr>
              <p:cNvSpPr txBox="1"/>
              <p:nvPr/>
            </p:nvSpPr>
            <p:spPr>
              <a:xfrm>
                <a:off x="3086100" y="2637753"/>
                <a:ext cx="6997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QT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321773F5-9A1A-8BCF-3A14-8A39E47F5709}"/>
                  </a:ext>
                </a:extLst>
              </p:cNvPr>
              <p:cNvSpPr txBox="1"/>
              <p:nvPr/>
            </p:nvSpPr>
            <p:spPr>
              <a:xfrm>
                <a:off x="4057650" y="2637753"/>
                <a:ext cx="6997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449F8AF0-247D-8212-BC27-85DC526822CD}"/>
                  </a:ext>
                </a:extLst>
              </p:cNvPr>
              <p:cNvSpPr txBox="1"/>
              <p:nvPr/>
            </p:nvSpPr>
            <p:spPr>
              <a:xfrm>
                <a:off x="4972050" y="2637753"/>
                <a:ext cx="6997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14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EC928EE-EFD1-89EC-A9BB-53D0A2373D7D}"/>
                </a:ext>
              </a:extLst>
            </p:cNvPr>
            <p:cNvSpPr txBox="1"/>
            <p:nvPr/>
          </p:nvSpPr>
          <p:spPr>
            <a:xfrm>
              <a:off x="402598" y="694775"/>
              <a:ext cx="571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06A013B-2D55-0EFC-EDD7-3FB88D81DCEA}"/>
                </a:ext>
              </a:extLst>
            </p:cNvPr>
            <p:cNvSpPr txBox="1"/>
            <p:nvPr/>
          </p:nvSpPr>
          <p:spPr>
            <a:xfrm rot="18014119">
              <a:off x="1158687" y="6360225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931AC01B-2683-634E-68BA-3B04E632AE02}"/>
                </a:ext>
              </a:extLst>
            </p:cNvPr>
            <p:cNvSpPr txBox="1"/>
            <p:nvPr/>
          </p:nvSpPr>
          <p:spPr>
            <a:xfrm rot="18014119">
              <a:off x="2508595" y="6360225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6DEC41E2-930D-8977-1494-AF31D1075D29}"/>
                </a:ext>
              </a:extLst>
            </p:cNvPr>
            <p:cNvSpPr txBox="1"/>
            <p:nvPr/>
          </p:nvSpPr>
          <p:spPr>
            <a:xfrm rot="18014119">
              <a:off x="3853627" y="6360225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8BA22B44-EB7B-F529-5CD9-823C741C0ED4}"/>
                </a:ext>
              </a:extLst>
            </p:cNvPr>
            <p:cNvSpPr txBox="1"/>
            <p:nvPr/>
          </p:nvSpPr>
          <p:spPr>
            <a:xfrm rot="18014119">
              <a:off x="5378206" y="6360225"/>
              <a:ext cx="1067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485C561-22FA-3C3B-6240-DC450C13401E}"/>
                </a:ext>
              </a:extLst>
            </p:cNvPr>
            <p:cNvSpPr txBox="1"/>
            <p:nvPr/>
          </p:nvSpPr>
          <p:spPr>
            <a:xfrm rot="18014119">
              <a:off x="956587" y="6137289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59A24167-38B8-71D8-6988-3D18AA1D0B07}"/>
                </a:ext>
              </a:extLst>
            </p:cNvPr>
            <p:cNvSpPr txBox="1"/>
            <p:nvPr/>
          </p:nvSpPr>
          <p:spPr>
            <a:xfrm rot="18014119">
              <a:off x="965534" y="6294196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9D87CA6-3D94-B475-2EFF-957F75240357}"/>
                </a:ext>
              </a:extLst>
            </p:cNvPr>
            <p:cNvSpPr txBox="1"/>
            <p:nvPr/>
          </p:nvSpPr>
          <p:spPr>
            <a:xfrm rot="18014119">
              <a:off x="2306495" y="6137289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D476E33E-D02B-FF01-8DFB-DFB88D90B010}"/>
                </a:ext>
              </a:extLst>
            </p:cNvPr>
            <p:cNvSpPr txBox="1"/>
            <p:nvPr/>
          </p:nvSpPr>
          <p:spPr>
            <a:xfrm rot="18014119">
              <a:off x="2315442" y="6294196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B8C163C0-665C-FF11-9130-66DA8C426F2A}"/>
                </a:ext>
              </a:extLst>
            </p:cNvPr>
            <p:cNvSpPr txBox="1"/>
            <p:nvPr/>
          </p:nvSpPr>
          <p:spPr>
            <a:xfrm rot="18014119">
              <a:off x="3651527" y="6137289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C74E9458-4825-B77D-0F28-418C0D686D26}"/>
                </a:ext>
              </a:extLst>
            </p:cNvPr>
            <p:cNvSpPr txBox="1"/>
            <p:nvPr/>
          </p:nvSpPr>
          <p:spPr>
            <a:xfrm rot="18014119">
              <a:off x="3660474" y="6294196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98DE0CB7-26E4-2B7B-E217-B89FCD8AAFBA}"/>
                </a:ext>
              </a:extLst>
            </p:cNvPr>
            <p:cNvSpPr txBox="1"/>
            <p:nvPr/>
          </p:nvSpPr>
          <p:spPr>
            <a:xfrm rot="18014119">
              <a:off x="5176106" y="6137289"/>
              <a:ext cx="5510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A87DC39A-62B2-880B-33CF-B43FB171D89F}"/>
                </a:ext>
              </a:extLst>
            </p:cNvPr>
            <p:cNvSpPr txBox="1"/>
            <p:nvPr/>
          </p:nvSpPr>
          <p:spPr>
            <a:xfrm rot="18014119">
              <a:off x="5185053" y="6294196"/>
              <a:ext cx="9142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2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3418D01-1168-AE10-F1BF-73944B2A05A3}"/>
                </a:ext>
              </a:extLst>
            </p:cNvPr>
            <p:cNvSpPr txBox="1"/>
            <p:nvPr/>
          </p:nvSpPr>
          <p:spPr>
            <a:xfrm>
              <a:off x="342900" y="2873104"/>
              <a:ext cx="571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46AE260E-9335-E2B5-B419-834707917022}"/>
                </a:ext>
              </a:extLst>
            </p:cNvPr>
            <p:cNvSpPr txBox="1"/>
            <p:nvPr/>
          </p:nvSpPr>
          <p:spPr>
            <a:xfrm rot="16200000">
              <a:off x="-386146" y="5383627"/>
              <a:ext cx="20787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sor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s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01EA412-9D65-B15B-D544-7877751E98BA}"/>
                </a:ext>
              </a:extLst>
            </p:cNvPr>
            <p:cNvSpPr txBox="1"/>
            <p:nvPr/>
          </p:nvSpPr>
          <p:spPr>
            <a:xfrm rot="16200000">
              <a:off x="4250586" y="5383627"/>
              <a:ext cx="13620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sor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278F86E-CCBA-D279-799D-8F17074C7938}"/>
                </a:ext>
              </a:extLst>
            </p:cNvPr>
            <p:cNvSpPr txBox="1"/>
            <p:nvPr/>
          </p:nvSpPr>
          <p:spPr>
            <a:xfrm rot="16200000">
              <a:off x="-386518" y="3800182"/>
              <a:ext cx="20787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mplitude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s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D4D9AFD3-8AE2-C399-6F11-F93B6208944B}"/>
                </a:ext>
              </a:extLst>
            </p:cNvPr>
            <p:cNvSpPr txBox="1"/>
            <p:nvPr/>
          </p:nvSpPr>
          <p:spPr>
            <a:xfrm rot="16200000">
              <a:off x="4250214" y="3800182"/>
              <a:ext cx="13620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mplitude (</a:t>
              </a:r>
              <a:r>
                <a:rPr lang="en-US" sz="12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2954592-73C9-A477-EF25-EA49E841AC0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4400" y="1052494"/>
              <a:ext cx="1257300" cy="145288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CAD50C1-4F42-E676-23E9-D9B2A32D37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56354" y="1017569"/>
              <a:ext cx="1257300" cy="148780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6E38FEB-8C06-35F8-4988-A36617E0B64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67999" y="1066464"/>
              <a:ext cx="1257300" cy="143891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ECD7A9F-4281-CE1B-90BE-92FFA90BC66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72118" y="1248074"/>
              <a:ext cx="1257300" cy="12573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AB49AA3-A196-465E-D680-48F2C9C9E59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26589" y="3310255"/>
              <a:ext cx="1257300" cy="137604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B751CD8-9FBB-766F-8D97-EFEEACF4F8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45529"/>
            <a:stretch/>
          </p:blipFill>
          <p:spPr>
            <a:xfrm>
              <a:off x="2228850" y="3262278"/>
              <a:ext cx="1257300" cy="1400166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C04FDB0-3D09-26EC-9710-589B004EF7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30918"/>
            <a:stretch/>
          </p:blipFill>
          <p:spPr>
            <a:xfrm>
              <a:off x="3621198" y="3331858"/>
              <a:ext cx="1187450" cy="133663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A6E714A2-882A-3477-ADAA-C7A944FEE5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b="30918"/>
            <a:stretch/>
          </p:blipFill>
          <p:spPr>
            <a:xfrm>
              <a:off x="5099050" y="3283221"/>
              <a:ext cx="1187450" cy="140901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7B887D88-D1DC-3860-DA7B-8E0419B03F1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39495" y="4642376"/>
              <a:ext cx="1334135" cy="2116455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F6C736E-A763-E031-9483-E14A2C8C75D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219299" y="4718050"/>
              <a:ext cx="1264285" cy="2025650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5DB7F3CF-62D2-E978-2055-9EBC47B36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544363" y="4732020"/>
              <a:ext cx="1264285" cy="201168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107C7321-D80E-606C-36E1-B590179020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022215" y="4899660"/>
              <a:ext cx="1264285" cy="1215390"/>
            </a:xfrm>
            <a:prstGeom prst="rect">
              <a:avLst/>
            </a:prstGeom>
          </p:spPr>
        </p:pic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E2908C54-068E-5147-9104-DAC94EADC53A}"/>
              </a:ext>
            </a:extLst>
          </p:cNvPr>
          <p:cNvSpPr txBox="1"/>
          <p:nvPr/>
        </p:nvSpPr>
        <p:spPr>
          <a:xfrm>
            <a:off x="2800350" y="655476"/>
            <a:ext cx="13716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cn5a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/</a:t>
            </a:r>
            <a:r>
              <a:rPr lang="el-GR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Δ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PQ</a:t>
            </a:r>
            <a:endParaRPr lang="en-US" sz="1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18921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D159AA32-F6B7-9EEA-D1E1-E236460A5776}"/>
              </a:ext>
            </a:extLst>
          </p:cNvPr>
          <p:cNvSpPr txBox="1"/>
          <p:nvPr/>
        </p:nvSpPr>
        <p:spPr>
          <a:xfrm rot="16200000">
            <a:off x="15964" y="3953700"/>
            <a:ext cx="18916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17C4DC4-57DF-4024-603F-B4FBCB9FDD7B}"/>
              </a:ext>
            </a:extLst>
          </p:cNvPr>
          <p:cNvSpPr txBox="1"/>
          <p:nvPr/>
        </p:nvSpPr>
        <p:spPr>
          <a:xfrm>
            <a:off x="2721297" y="126018"/>
            <a:ext cx="13716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cn5a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/</a:t>
            </a:r>
            <a:r>
              <a:rPr lang="el-GR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Δ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PQ</a:t>
            </a:r>
            <a:endParaRPr lang="en-US" sz="1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DAE2835-F33D-2D39-E2EA-E8BE89435F08}"/>
              </a:ext>
            </a:extLst>
          </p:cNvPr>
          <p:cNvGrpSpPr/>
          <p:nvPr/>
        </p:nvGrpSpPr>
        <p:grpSpPr>
          <a:xfrm>
            <a:off x="514350" y="3280430"/>
            <a:ext cx="5935801" cy="4681954"/>
            <a:chOff x="418880" y="3280430"/>
            <a:chExt cx="5935801" cy="468195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A43AB39-CBEE-F1BC-CDF4-2EF36F27C16D}"/>
                </a:ext>
              </a:extLst>
            </p:cNvPr>
            <p:cNvSpPr txBox="1"/>
            <p:nvPr/>
          </p:nvSpPr>
          <p:spPr>
            <a:xfrm rot="16200000">
              <a:off x="-1250214" y="5465319"/>
              <a:ext cx="36767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ross-correlation w/ RR interval 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2FFB342-F418-00BC-57A3-564E09D8189D}"/>
                </a:ext>
              </a:extLst>
            </p:cNvPr>
            <p:cNvSpPr txBox="1"/>
            <p:nvPr/>
          </p:nvSpPr>
          <p:spPr>
            <a:xfrm>
              <a:off x="1869459" y="7623830"/>
              <a:ext cx="32333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Lag (</a:t>
              </a:r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9153D86-9738-E21C-7D3D-5B36EFAE02D5}"/>
                </a:ext>
              </a:extLst>
            </p:cNvPr>
            <p:cNvSpPr txBox="1"/>
            <p:nvPr/>
          </p:nvSpPr>
          <p:spPr>
            <a:xfrm rot="16200000">
              <a:off x="15964" y="5268149"/>
              <a:ext cx="18916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HF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EE12009-8C1E-2375-D6C6-375B4BAAB8B0}"/>
                </a:ext>
              </a:extLst>
            </p:cNvPr>
            <p:cNvSpPr txBox="1"/>
            <p:nvPr/>
          </p:nvSpPr>
          <p:spPr>
            <a:xfrm rot="16200000">
              <a:off x="15964" y="6696899"/>
              <a:ext cx="18916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tivity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CC270EB-1EE5-C931-BB58-AC5624F1FD87}"/>
                </a:ext>
              </a:extLst>
            </p:cNvPr>
            <p:cNvSpPr txBox="1"/>
            <p:nvPr/>
          </p:nvSpPr>
          <p:spPr>
            <a:xfrm>
              <a:off x="1496931" y="3280430"/>
              <a:ext cx="9164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LF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32386F7-11EA-4CE4-41A1-34CCBB9199B1}"/>
                </a:ext>
              </a:extLst>
            </p:cNvPr>
            <p:cNvSpPr txBox="1"/>
            <p:nvPr/>
          </p:nvSpPr>
          <p:spPr>
            <a:xfrm>
              <a:off x="2686296" y="3280430"/>
              <a:ext cx="16253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F</a:t>
              </a:r>
              <a:r>
                <a:rPr lang="en-US" sz="16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DFCDDFE-2648-ED42-FC3B-837249437EDE}"/>
                </a:ext>
              </a:extLst>
            </p:cNvPr>
            <p:cNvSpPr txBox="1"/>
            <p:nvPr/>
          </p:nvSpPr>
          <p:spPr>
            <a:xfrm>
              <a:off x="4123479" y="3280430"/>
              <a:ext cx="18767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L-RF</a:t>
              </a:r>
              <a:r>
                <a:rPr 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wk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EFF9A89B-1B80-784C-D313-2473692CF6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56393" y="3551400"/>
              <a:ext cx="1627505" cy="1362075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6EF10E0C-5AE4-7AB6-D050-A04229D8E5B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29574" y="3551400"/>
              <a:ext cx="1627505" cy="1362075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9AE383D5-D507-729A-285B-227DFDDEC0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73333" y="3551400"/>
              <a:ext cx="1627505" cy="1362075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842FF7D8-1774-8E8C-C414-B991EC88593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56393" y="4957651"/>
              <a:ext cx="1627505" cy="1362075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C2580C77-8187-65B1-0838-BBDDF19E38E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56393" y="6333727"/>
              <a:ext cx="1627505" cy="1362075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CE2A71D-C54E-A5EC-140D-B2EF74E4F5E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629574" y="6333727"/>
              <a:ext cx="1627505" cy="1362075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8DE69E5C-BAC0-C64F-8528-22B961CCFCD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173333" y="6333727"/>
              <a:ext cx="1627505" cy="1362075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B6640074-5714-FA95-1883-B005AB7498A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629574" y="4957651"/>
              <a:ext cx="1627505" cy="1362075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02B1FD69-AE2B-8AF0-8905-42064099BC1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173333" y="4957651"/>
              <a:ext cx="1627505" cy="1362075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94CFA11-A81A-9E07-ECE3-3627A766298B}"/>
                </a:ext>
              </a:extLst>
            </p:cNvPr>
            <p:cNvSpPr txBox="1"/>
            <p:nvPr/>
          </p:nvSpPr>
          <p:spPr>
            <a:xfrm>
              <a:off x="1924914" y="7078523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0.6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F8D0516-77E7-F989-14EC-8968D7339844}"/>
                </a:ext>
              </a:extLst>
            </p:cNvPr>
            <p:cNvSpPr txBox="1"/>
            <p:nvPr/>
          </p:nvSpPr>
          <p:spPr>
            <a:xfrm>
              <a:off x="3407097" y="7078523"/>
              <a:ext cx="65769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0.55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43FA0D9-1A32-635C-4AA1-3FD31B6FEF87}"/>
                </a:ext>
              </a:extLst>
            </p:cNvPr>
            <p:cNvSpPr txBox="1"/>
            <p:nvPr/>
          </p:nvSpPr>
          <p:spPr>
            <a:xfrm>
              <a:off x="4987086" y="7078523"/>
              <a:ext cx="79252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0.47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429A59A-E82C-441B-A692-97471E3F8249}"/>
                </a:ext>
              </a:extLst>
            </p:cNvPr>
            <p:cNvSpPr txBox="1"/>
            <p:nvPr/>
          </p:nvSpPr>
          <p:spPr>
            <a:xfrm>
              <a:off x="5432389" y="7012562"/>
              <a:ext cx="9222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846B845-2B06-1513-7E01-5578A84A6EA3}"/>
                </a:ext>
              </a:extLst>
            </p:cNvPr>
            <p:cNvSpPr txBox="1"/>
            <p:nvPr/>
          </p:nvSpPr>
          <p:spPr>
            <a:xfrm>
              <a:off x="3795933" y="7004981"/>
              <a:ext cx="9222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7521820-C5D2-B1AE-E8DD-3400C6394C35}"/>
                </a:ext>
              </a:extLst>
            </p:cNvPr>
            <p:cNvSpPr txBox="1"/>
            <p:nvPr/>
          </p:nvSpPr>
          <p:spPr>
            <a:xfrm>
              <a:off x="1950560" y="4359438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0.8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60D740B-3D12-C848-09BA-E16141DEEFF7}"/>
                </a:ext>
              </a:extLst>
            </p:cNvPr>
            <p:cNvSpPr txBox="1"/>
            <p:nvPr/>
          </p:nvSpPr>
          <p:spPr>
            <a:xfrm>
              <a:off x="3511772" y="4368212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0.9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4DA521C-3A33-0DE8-6971-8AB58DEC1FFF}"/>
                </a:ext>
              </a:extLst>
            </p:cNvPr>
            <p:cNvSpPr txBox="1"/>
            <p:nvPr/>
          </p:nvSpPr>
          <p:spPr>
            <a:xfrm>
              <a:off x="5091760" y="4365286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0.89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8F0C452-3AAE-A77E-EF99-9A8E3A1206A1}"/>
                </a:ext>
              </a:extLst>
            </p:cNvPr>
            <p:cNvSpPr txBox="1"/>
            <p:nvPr/>
          </p:nvSpPr>
          <p:spPr>
            <a:xfrm>
              <a:off x="1950560" y="5099458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7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C16DD28-B570-464A-2D30-71C9AE9C14B6}"/>
                </a:ext>
              </a:extLst>
            </p:cNvPr>
            <p:cNvSpPr txBox="1"/>
            <p:nvPr/>
          </p:nvSpPr>
          <p:spPr>
            <a:xfrm>
              <a:off x="3511772" y="5099458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8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A02593E-9B6B-8923-C7F3-46D434E98D2B}"/>
                </a:ext>
              </a:extLst>
            </p:cNvPr>
            <p:cNvSpPr txBox="1"/>
            <p:nvPr/>
          </p:nvSpPr>
          <p:spPr>
            <a:xfrm>
              <a:off x="5091760" y="5099458"/>
              <a:ext cx="5173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88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2FB3120-2E90-5193-15BA-750E0E6F715C}"/>
                </a:ext>
              </a:extLst>
            </p:cNvPr>
            <p:cNvSpPr txBox="1"/>
            <p:nvPr/>
          </p:nvSpPr>
          <p:spPr>
            <a:xfrm>
              <a:off x="5383348" y="5037902"/>
              <a:ext cx="9222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BC35FC9B-FD57-9609-9DA0-8EAB523EBA84}"/>
              </a:ext>
            </a:extLst>
          </p:cNvPr>
          <p:cNvSpPr txBox="1"/>
          <p:nvPr/>
        </p:nvSpPr>
        <p:spPr>
          <a:xfrm>
            <a:off x="88654" y="7987784"/>
            <a:ext cx="2583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5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9044B2-1599-1493-7309-7B896DC34D82}"/>
              </a:ext>
            </a:extLst>
          </p:cNvPr>
          <p:cNvSpPr txBox="1"/>
          <p:nvPr/>
        </p:nvSpPr>
        <p:spPr>
          <a:xfrm rot="18014119">
            <a:off x="2356358" y="2629671"/>
            <a:ext cx="551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L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62E1C9-481A-B742-DEBE-819E44E99F4F}"/>
              </a:ext>
            </a:extLst>
          </p:cNvPr>
          <p:cNvSpPr txBox="1"/>
          <p:nvPr/>
        </p:nvSpPr>
        <p:spPr>
          <a:xfrm rot="18014119">
            <a:off x="2800247" y="2786578"/>
            <a:ext cx="914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F</a:t>
            </a:r>
            <a:r>
              <a:rPr lang="en-US" sz="12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625D69-5E72-9521-2762-4AA5B67A5BE8}"/>
              </a:ext>
            </a:extLst>
          </p:cNvPr>
          <p:cNvSpPr txBox="1"/>
          <p:nvPr/>
        </p:nvSpPr>
        <p:spPr>
          <a:xfrm rot="18014119">
            <a:off x="3332350" y="2843870"/>
            <a:ext cx="1067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-RF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wk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758DE2-D3CB-F95F-475D-4B9F2145002C}"/>
              </a:ext>
            </a:extLst>
          </p:cNvPr>
          <p:cNvSpPr txBox="1"/>
          <p:nvPr/>
        </p:nvSpPr>
        <p:spPr>
          <a:xfrm rot="16200000">
            <a:off x="958375" y="1753702"/>
            <a:ext cx="2078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tivity (AU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F27CE15-FC80-7990-323E-FF64753B35FB}"/>
              </a:ext>
            </a:extLst>
          </p:cNvPr>
          <p:cNvSpPr txBox="1"/>
          <p:nvPr/>
        </p:nvSpPr>
        <p:spPr>
          <a:xfrm>
            <a:off x="4305869" y="1002092"/>
            <a:ext cx="140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ight cycle</a:t>
            </a:r>
            <a:endParaRPr lang="en-US" sz="12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FD3251-16B5-46D8-7A1B-0FD7CF12270C}"/>
              </a:ext>
            </a:extLst>
          </p:cNvPr>
          <p:cNvSpPr txBox="1"/>
          <p:nvPr/>
        </p:nvSpPr>
        <p:spPr>
          <a:xfrm>
            <a:off x="4305869" y="1207840"/>
            <a:ext cx="15533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rk cycle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8D106A20-FE3E-DDB1-6B9C-EB5191089D5C}"/>
              </a:ext>
            </a:extLst>
          </p:cNvPr>
          <p:cNvSpPr/>
          <p:nvPr/>
        </p:nvSpPr>
        <p:spPr>
          <a:xfrm>
            <a:off x="4276024" y="1279091"/>
            <a:ext cx="91440" cy="91440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D3B9949D-431E-6A31-99B7-5A407E99BDAD}"/>
              </a:ext>
            </a:extLst>
          </p:cNvPr>
          <p:cNvSpPr/>
          <p:nvPr/>
        </p:nvSpPr>
        <p:spPr>
          <a:xfrm>
            <a:off x="4276024" y="1111586"/>
            <a:ext cx="91440" cy="9144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2C6E568-6222-7420-0A29-709F16DCE1B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54825" y="857565"/>
            <a:ext cx="2095500" cy="17272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FB12AB7-236F-DE52-D9B3-2BC606539A27}"/>
              </a:ext>
            </a:extLst>
          </p:cNvPr>
          <p:cNvSpPr txBox="1"/>
          <p:nvPr/>
        </p:nvSpPr>
        <p:spPr>
          <a:xfrm>
            <a:off x="567739" y="602218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84BF3FF-8687-76EC-AB3C-AE16615AD2DE}"/>
              </a:ext>
            </a:extLst>
          </p:cNvPr>
          <p:cNvSpPr txBox="1"/>
          <p:nvPr/>
        </p:nvSpPr>
        <p:spPr>
          <a:xfrm>
            <a:off x="514350" y="3276661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34620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BD2306678597D4CAB5E3A6F05AE9EFF" ma:contentTypeVersion="18" ma:contentTypeDescription="Create a new document." ma:contentTypeScope="" ma:versionID="4f771d808420b0057e82fe1f03706b01">
  <xsd:schema xmlns:xsd="http://www.w3.org/2001/XMLSchema" xmlns:xs="http://www.w3.org/2001/XMLSchema" xmlns:p="http://schemas.microsoft.com/office/2006/metadata/properties" xmlns:ns3="4e76705d-a460-4aa8-b956-674e7766ea5e" xmlns:ns4="ecb33cd7-c556-4a48-b664-4bf9f2cd1be2" targetNamespace="http://schemas.microsoft.com/office/2006/metadata/properties" ma:root="true" ma:fieldsID="16b3fff752ec050df1b085f2aabe17cd" ns3:_="" ns4:_="">
    <xsd:import namespace="4e76705d-a460-4aa8-b956-674e7766ea5e"/>
    <xsd:import namespace="ecb33cd7-c556-4a48-b664-4bf9f2cd1be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ServiceOCR" minOccurs="0"/>
                <xsd:element ref="ns3:MediaLengthInSeconds" minOccurs="0"/>
                <xsd:element ref="ns3:_activity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76705d-a460-4aa8-b956-674e7766ea5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b33cd7-c556-4a48-b664-4bf9f2cd1be2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e76705d-a460-4aa8-b956-674e7766ea5e" xsi:nil="true"/>
  </documentManagement>
</p:properties>
</file>

<file path=customXml/itemProps1.xml><?xml version="1.0" encoding="utf-8"?>
<ds:datastoreItem xmlns:ds="http://schemas.openxmlformats.org/officeDocument/2006/customXml" ds:itemID="{AF527AD6-C469-44DB-9CBB-BEE7C597AD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e76705d-a460-4aa8-b956-674e7766ea5e"/>
    <ds:schemaRef ds:uri="ecb33cd7-c556-4a48-b664-4bf9f2cd1be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52D54B1-85A1-4654-B941-227D330F7D2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800EAD7-2AC5-4E51-AF05-192569A43125}">
  <ds:schemaRefs>
    <ds:schemaRef ds:uri="ecb33cd7-c556-4a48-b664-4bf9f2cd1be2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4e76705d-a460-4aa8-b956-674e7766ea5e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405</TotalTime>
  <Words>226</Words>
  <Application>Microsoft Office PowerPoint</Application>
  <PresentationFormat>Letter Paper (8.5x11 in)</PresentationFormat>
  <Paragraphs>130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isle, Brian P.</dc:creator>
  <cp:lastModifiedBy>Stumpf, Elizabeth S.</cp:lastModifiedBy>
  <cp:revision>58</cp:revision>
  <dcterms:created xsi:type="dcterms:W3CDTF">2023-06-13T18:50:33Z</dcterms:created>
  <dcterms:modified xsi:type="dcterms:W3CDTF">2024-04-18T14:05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BD2306678597D4CAB5E3A6F05AE9EFF</vt:lpwstr>
  </property>
</Properties>
</file>